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-348" y="-48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1/21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image" Target="../media/image18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12" Type="http://schemas.openxmlformats.org/officeDocument/2006/relationships/image" Target="../media/image17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11" Type="http://schemas.openxmlformats.org/officeDocument/2006/relationships/image" Target="../media/image16.jpeg"/><Relationship Id="rId5" Type="http://schemas.openxmlformats.org/officeDocument/2006/relationships/image" Target="../media/image10.jpeg"/><Relationship Id="rId10" Type="http://schemas.openxmlformats.org/officeDocument/2006/relationships/image" Target="../media/image15.jpe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/>
          <p:cNvSpPr txBox="1"/>
          <p:nvPr/>
        </p:nvSpPr>
        <p:spPr>
          <a:xfrm>
            <a:off x="0" y="1109980"/>
            <a:ext cx="12192000" cy="398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riginal western </a:t>
            </a:r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lots for Fig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endParaRPr lang="en-US" altLang="zh-CN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3565" y="3255984"/>
            <a:ext cx="1880870" cy="559435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3565" y="2394924"/>
            <a:ext cx="1880235" cy="549275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95285" y="2394924"/>
            <a:ext cx="1795780" cy="5492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95285" y="3255984"/>
            <a:ext cx="1795780" cy="55943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8" name="图片 27" descr="irhom2-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98190" y="2394924"/>
            <a:ext cx="1937385" cy="549275"/>
          </a:xfrm>
          <a:prstGeom prst="rect">
            <a:avLst/>
          </a:prstGeom>
        </p:spPr>
      </p:pic>
      <p:pic>
        <p:nvPicPr>
          <p:cNvPr id="29" name="图片 28" descr="gapdh-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98190" y="3255984"/>
            <a:ext cx="1937385" cy="549275"/>
          </a:xfrm>
          <a:prstGeom prst="rect">
            <a:avLst/>
          </a:prstGeom>
        </p:spPr>
      </p:pic>
      <p:sp>
        <p:nvSpPr>
          <p:cNvPr id="42" name="文本框 5"/>
          <p:cNvSpPr txBox="1">
            <a:spLocks noChangeArrowheads="1"/>
          </p:cNvSpPr>
          <p:nvPr/>
        </p:nvSpPr>
        <p:spPr bwMode="auto">
          <a:xfrm>
            <a:off x="1987166" y="2500780"/>
            <a:ext cx="1039812" cy="3371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eaLnBrk="0" hangingPunct="0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Rhom2</a:t>
            </a:r>
          </a:p>
        </p:txBody>
      </p:sp>
      <p:sp>
        <p:nvSpPr>
          <p:cNvPr id="46" name="文本框 3"/>
          <p:cNvSpPr txBox="1">
            <a:spLocks noChangeArrowheads="1"/>
          </p:cNvSpPr>
          <p:nvPr/>
        </p:nvSpPr>
        <p:spPr bwMode="auto">
          <a:xfrm>
            <a:off x="1986915" y="3367109"/>
            <a:ext cx="936625" cy="3371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21"/>
          <p:cNvSpPr txBox="1"/>
          <p:nvPr/>
        </p:nvSpPr>
        <p:spPr>
          <a:xfrm>
            <a:off x="0" y="1105148"/>
            <a:ext cx="12192000" cy="398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riginal western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blots for Fig. </a:t>
            </a:r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endParaRPr lang="en-US" altLang="zh-CN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50258" y="2972887"/>
            <a:ext cx="2164080" cy="521208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2609" y="3706641"/>
            <a:ext cx="2075688" cy="551688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3548" y="3706731"/>
            <a:ext cx="2112264" cy="551688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0169" y="3744519"/>
            <a:ext cx="2103120" cy="508050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50258" y="3721747"/>
            <a:ext cx="2165604" cy="521209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2924" y="2196726"/>
            <a:ext cx="2090928" cy="524256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6207" y="2204833"/>
            <a:ext cx="2095500" cy="524256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3974" y="2212784"/>
            <a:ext cx="2095500" cy="508049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50258" y="2213723"/>
            <a:ext cx="2164080" cy="521208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2924" y="2928437"/>
            <a:ext cx="2095500" cy="551688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6121" y="2929073"/>
            <a:ext cx="2101596" cy="551688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3979" y="2972076"/>
            <a:ext cx="2095500" cy="508049"/>
          </a:xfrm>
          <a:prstGeom prst="rect">
            <a:avLst/>
          </a:prstGeom>
        </p:spPr>
      </p:pic>
      <p:sp>
        <p:nvSpPr>
          <p:cNvPr id="42" name="文本框 5"/>
          <p:cNvSpPr txBox="1">
            <a:spLocks noChangeArrowheads="1"/>
          </p:cNvSpPr>
          <p:nvPr/>
        </p:nvSpPr>
        <p:spPr bwMode="auto">
          <a:xfrm>
            <a:off x="1225801" y="2305496"/>
            <a:ext cx="1039812" cy="3371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eaLnBrk="0" hangingPunct="0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Rhom2</a:t>
            </a:r>
          </a:p>
        </p:txBody>
      </p:sp>
      <p:sp>
        <p:nvSpPr>
          <p:cNvPr id="44" name="文本框 20"/>
          <p:cNvSpPr txBox="1">
            <a:spLocks noChangeArrowheads="1"/>
          </p:cNvSpPr>
          <p:nvPr/>
        </p:nvSpPr>
        <p:spPr bwMode="auto">
          <a:xfrm>
            <a:off x="1319519" y="3036085"/>
            <a:ext cx="819150" cy="3371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TACE</a:t>
            </a:r>
          </a:p>
        </p:txBody>
      </p:sp>
      <p:sp>
        <p:nvSpPr>
          <p:cNvPr id="46" name="文本框 3"/>
          <p:cNvSpPr txBox="1">
            <a:spLocks noChangeArrowheads="1"/>
          </p:cNvSpPr>
          <p:nvPr/>
        </p:nvSpPr>
        <p:spPr bwMode="auto">
          <a:xfrm>
            <a:off x="1177290" y="3813810"/>
            <a:ext cx="936625" cy="3371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9</Words>
  <Application>Microsoft Office PowerPoint</Application>
  <PresentationFormat>宽屏</PresentationFormat>
  <Paragraphs>7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微软雅黑</vt:lpstr>
      <vt:lpstr>Arial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Lotus</cp:lastModifiedBy>
  <cp:revision>22</cp:revision>
  <dcterms:created xsi:type="dcterms:W3CDTF">2020-06-17T09:03:00Z</dcterms:created>
  <dcterms:modified xsi:type="dcterms:W3CDTF">2020-11-21T03:33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132</vt:lpwstr>
  </property>
</Properties>
</file>